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236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1186017"/>
              </p:ext>
            </p:extLst>
          </p:nvPr>
        </p:nvGraphicFramePr>
        <p:xfrm>
          <a:off x="762000" y="547390"/>
          <a:ext cx="3733800" cy="91122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01401"/>
                <a:gridCol w="1422799"/>
                <a:gridCol w="609600"/>
              </a:tblGrid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</a:rPr>
                        <a:t>Family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</a:rPr>
                        <a:t>Species</a:t>
                      </a:r>
                      <a:endParaRPr lang="en-US" sz="800" b="1" i="0" u="none" strike="noStrike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</a:rPr>
                        <a:t>Abbreviation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ari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scomitrella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en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</a:rPr>
                        <a:t>pp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aginell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aginell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sile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silea quadrifoli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qu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ad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as rumphi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ru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nkgo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nkgo bilob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gb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n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cea abie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a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orell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orella trichopod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ymphae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phar adven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a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stolochi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stolochia fimbria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f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ur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sea american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ster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stera marin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zm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a acumina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a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canthus giganteu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g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rghum bicolor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b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a may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z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icum virgat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v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aria italic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rdeum vulgar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hvu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ticum aestiv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ta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yza sativ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os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is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nifer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vv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t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rus sinens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s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ica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pay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p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v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ssypium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bore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g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abidopsis thalian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.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rat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l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pulus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chocarp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curbit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curbita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xim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uminos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cago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uncatul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t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uminos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Glycine max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g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uminos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olus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ulgar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vu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yophyll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lene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ifoli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l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er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ctuca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ativ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ls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rym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mulus guttatu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gu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otiana tabac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t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otiana benthamian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b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tunia hybrid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h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sicum annu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um lycopersic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l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S. pennelli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S. pimpinellifoli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p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anum tuberos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tu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s used in sequence alignments</a:t>
                      </a:r>
                      <a:endParaRPr lang="en-US" sz="8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sella grandiflor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g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uedoturritis turid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ysimum cheir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ec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llungiella halophyl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th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colmia maritim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epina irregular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rippa austriac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rau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amine hirsu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h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amine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exuos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f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amina impatien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i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ssica nap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b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um usitatissim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l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t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rus clemantin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c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t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trus reticula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r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phorbi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cinus communi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rc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phorbi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ihot esculen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er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nara cardunculu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s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unus persic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s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us domestic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d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uminos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er arientinum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guminos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gna unguiculata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vu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v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obroma cacao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t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curbit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cumis melo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m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ccharum sp.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s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ccharum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ficinarum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o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acea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chypodium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chyon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40" marR="4540" marT="454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</a:rPr>
                        <a:t>bd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40" marR="4540" marT="4540" marB="0" anchor="b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3400" y="214699"/>
            <a:ext cx="5486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1</a:t>
            </a:r>
            <a:r>
              <a:rPr lang="en-US" sz="1200" b="1" dirty="0"/>
              <a:t>. </a:t>
            </a:r>
            <a:r>
              <a:rPr lang="en-US" sz="1200" dirty="0"/>
              <a:t>Plant species used for small RNA </a:t>
            </a:r>
            <a:r>
              <a:rPr lang="en-US" sz="1200" dirty="0" smtClean="0"/>
              <a:t>analysi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59521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1</Words>
  <Application>Microsoft Office PowerPoint</Application>
  <PresentationFormat>A4 Paper (210x297 mm)</PresentationFormat>
  <Paragraphs>20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2</cp:revision>
  <dcterms:created xsi:type="dcterms:W3CDTF">2006-08-16T00:00:00Z</dcterms:created>
  <dcterms:modified xsi:type="dcterms:W3CDTF">2014-08-25T07:48:16Z</dcterms:modified>
</cp:coreProperties>
</file>